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C48E9-F562-445F-9E52-0A0819F38A2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226284-6519-47CF-8002-C16139EFC59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1BE52D-2D19-4D99-AA5A-CE406C68157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D6DFB-479A-4781-887B-ED0F860386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7B76C5-F61C-4423-B3A8-6495C73D20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BDF074-B673-402E-BF5F-716FDA794C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C0A4C2-B410-484C-9F5D-9D00CE92E1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DA268-A970-4335-821A-AF7FF6F4F8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25AFD-058A-429A-BA96-B1B6F70259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3149C0-B955-4D05-B412-F42184BD7D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4BCD09-58F3-45BF-B32A-0CF0FE6BDC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37DEC-A381-41AA-8D89-18C9F1B5056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174125C-DE19-4E76-AD63-AC4C17C4830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826920" y="1330200"/>
            <a:ext cx="4032360" cy="4330800"/>
            <a:chOff x="826920" y="1330200"/>
            <a:chExt cx="4032360" cy="433080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17556" t="16726" r="25649" b="37612"/>
            <a:stretch/>
          </p:blipFill>
          <p:spPr>
            <a:xfrm>
              <a:off x="826920" y="1413000"/>
              <a:ext cx="4032360" cy="4248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106380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38132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71648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05632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38176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99268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36096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65796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906000" y="133020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648160" y="13302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221720" y="1330200"/>
              <a:ext cx="43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4" name=""/>
          <p:cNvSpPr/>
          <p:nvPr/>
        </p:nvSpPr>
        <p:spPr>
          <a:xfrm>
            <a:off x="110520" y="8424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829080" y="9079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"/>
          <p:cNvGrpSpPr/>
          <p:nvPr/>
        </p:nvGrpSpPr>
        <p:grpSpPr>
          <a:xfrm>
            <a:off x="1427040" y="780840"/>
            <a:ext cx="5877000" cy="3801960"/>
            <a:chOff x="1427040" y="780840"/>
            <a:chExt cx="5877000" cy="3801960"/>
          </a:xfrm>
        </p:grpSpPr>
        <p:sp>
          <p:nvSpPr>
            <p:cNvPr id="57" name=""/>
            <p:cNvSpPr/>
            <p:nvPr/>
          </p:nvSpPr>
          <p:spPr>
            <a:xfrm>
              <a:off x="2212920" y="947520"/>
              <a:ext cx="4349880" cy="2903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403360" y="947520"/>
              <a:ext cx="249480" cy="2884680"/>
            </a:xfrm>
            <a:custGeom>
              <a:avLst/>
              <a:gdLst/>
              <a:ahLst/>
              <a:rect l="l" t="t" r="r" b="b"/>
              <a:pathLst>
                <a:path w="103" h="630">
                  <a:moveTo>
                    <a:pt x="0" y="630"/>
                  </a:moveTo>
                  <a:lnTo>
                    <a:pt x="0" y="630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630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565520" y="1295280"/>
              <a:ext cx="250920" cy="2546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565520" y="928440"/>
              <a:ext cx="249480" cy="2916360"/>
            </a:xfrm>
            <a:custGeom>
              <a:avLst/>
              <a:gdLst/>
              <a:ahLst/>
              <a:rect l="l" t="t" r="r" b="b"/>
              <a:pathLst>
                <a:path w="103" h="1052">
                  <a:moveTo>
                    <a:pt x="0" y="1052"/>
                  </a:moveTo>
                  <a:lnTo>
                    <a:pt x="0" y="1052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1052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782800" y="947520"/>
              <a:ext cx="249480" cy="2889360"/>
            </a:xfrm>
            <a:custGeom>
              <a:avLst/>
              <a:gdLst/>
              <a:ahLst/>
              <a:rect l="l" t="t" r="r" b="b"/>
              <a:pathLst>
                <a:path w="103" h="464">
                  <a:moveTo>
                    <a:pt x="0" y="464"/>
                  </a:moveTo>
                  <a:lnTo>
                    <a:pt x="0" y="464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464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4944960" y="1150920"/>
              <a:ext cx="250920" cy="26906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4944960" y="928440"/>
              <a:ext cx="249480" cy="2903760"/>
            </a:xfrm>
            <a:custGeom>
              <a:avLst/>
              <a:gdLst/>
              <a:ahLst/>
              <a:rect l="l" t="t" r="r" b="b"/>
              <a:pathLst>
                <a:path w="103" h="1112">
                  <a:moveTo>
                    <a:pt x="0" y="1112"/>
                  </a:moveTo>
                  <a:lnTo>
                    <a:pt x="0" y="1112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1112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162240" y="947520"/>
              <a:ext cx="249120" cy="2889360"/>
            </a:xfrm>
            <a:custGeom>
              <a:avLst/>
              <a:gdLst/>
              <a:ahLst/>
              <a:rect l="l" t="t" r="r" b="b"/>
              <a:pathLst>
                <a:path w="103" h="476">
                  <a:moveTo>
                    <a:pt x="0" y="476"/>
                  </a:moveTo>
                  <a:lnTo>
                    <a:pt x="0" y="476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476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324400" y="1787400"/>
              <a:ext cx="250920" cy="20541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324400" y="928440"/>
              <a:ext cx="249480" cy="2900520"/>
            </a:xfrm>
            <a:custGeom>
              <a:avLst/>
              <a:gdLst/>
              <a:ahLst/>
              <a:rect l="l" t="t" r="r" b="b"/>
              <a:pathLst>
                <a:path w="103" h="848">
                  <a:moveTo>
                    <a:pt x="0" y="848"/>
                  </a:moveTo>
                  <a:lnTo>
                    <a:pt x="0" y="848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848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543480" y="947520"/>
              <a:ext cx="247320" cy="2884680"/>
            </a:xfrm>
            <a:custGeom>
              <a:avLst/>
              <a:gdLst/>
              <a:ahLst/>
              <a:rect l="l" t="t" r="r" b="b"/>
              <a:pathLst>
                <a:path w="103" h="620">
                  <a:moveTo>
                    <a:pt x="0" y="620"/>
                  </a:moveTo>
                  <a:lnTo>
                    <a:pt x="0" y="620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620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703840" y="1352520"/>
              <a:ext cx="250920" cy="248904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703840" y="928440"/>
              <a:ext cx="249120" cy="2906640"/>
            </a:xfrm>
            <a:custGeom>
              <a:avLst/>
              <a:gdLst/>
              <a:ahLst/>
              <a:rect l="l" t="t" r="r" b="b"/>
              <a:pathLst>
                <a:path w="103" h="1028">
                  <a:moveTo>
                    <a:pt x="0" y="1028"/>
                  </a:moveTo>
                  <a:lnTo>
                    <a:pt x="0" y="1028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1028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922560" y="947520"/>
              <a:ext cx="249480" cy="2887560"/>
            </a:xfrm>
            <a:custGeom>
              <a:avLst/>
              <a:gdLst/>
              <a:ahLst/>
              <a:rect l="l" t="t" r="r" b="b"/>
              <a:pathLst>
                <a:path w="103" h="461">
                  <a:moveTo>
                    <a:pt x="0" y="461"/>
                  </a:moveTo>
                  <a:lnTo>
                    <a:pt x="0" y="461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461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6083280" y="1830240"/>
              <a:ext cx="252360" cy="20113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6083280" y="928440"/>
              <a:ext cx="249120" cy="2909880"/>
            </a:xfrm>
            <a:custGeom>
              <a:avLst/>
              <a:gdLst/>
              <a:ahLst/>
              <a:rect l="l" t="t" r="r" b="b"/>
              <a:pathLst>
                <a:path w="103" h="830">
                  <a:moveTo>
                    <a:pt x="0" y="830"/>
                  </a:moveTo>
                  <a:lnTo>
                    <a:pt x="0" y="830"/>
                  </a:lnTo>
                  <a:lnTo>
                    <a:pt x="0" y="0"/>
                  </a:lnTo>
                  <a:lnTo>
                    <a:pt x="103" y="0"/>
                  </a:lnTo>
                  <a:lnTo>
                    <a:pt x="103" y="830"/>
                  </a:lnTo>
                </a:path>
              </a:pathLst>
            </a:custGeom>
            <a:noFill/>
            <a:ln w="4284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212920" y="3841560"/>
              <a:ext cx="43513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2212920" y="947160"/>
              <a:ext cx="0" cy="28940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H="1">
              <a:off x="2130120" y="3841560"/>
              <a:ext cx="82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941480" y="371124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H="1">
              <a:off x="2130120" y="3262320"/>
              <a:ext cx="82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816200" y="31320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2130120" y="2684160"/>
              <a:ext cx="82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816200" y="25542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H="1">
              <a:off x="2130120" y="2104920"/>
              <a:ext cx="82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816200" y="19746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2130120" y="1527120"/>
              <a:ext cx="82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816200" y="139680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H="1">
              <a:off x="2130120" y="947520"/>
              <a:ext cx="8244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687680" y="81756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rot="16200000">
              <a:off x="-38160" y="2259360"/>
              <a:ext cx="3220920" cy="28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900" spc="-1" strike="noStrike">
                  <a:solidFill>
                    <a:srgbClr val="000000"/>
                  </a:solidFill>
                  <a:latin typeface="Arial"/>
                </a:rPr>
                <a:t>% free (white)/bound (black)</a:t>
              </a: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270160" y="387504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647800" y="387504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025800" y="387504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3403440" y="387504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3781440" y="387504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429080" y="385596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806720" y="385596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184720" y="385596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3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5562360" y="385596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4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940360" y="3855960"/>
              <a:ext cx="48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G5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2498040" y="4214520"/>
              <a:ext cx="155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0.6 µM NS5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658760" y="4214520"/>
              <a:ext cx="155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Arial"/>
                </a:rPr>
                <a:t>1.8 µM NS5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2340000" y="4214520"/>
              <a:ext cx="187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500720" y="4214520"/>
              <a:ext cx="18716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6620040" y="3693960"/>
              <a:ext cx="1209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6620040" y="311436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6620040" y="253656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6620040" y="195732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6620040" y="1379520"/>
              <a:ext cx="241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7" name=""/>
            <p:cNvGrpSpPr/>
            <p:nvPr/>
          </p:nvGrpSpPr>
          <p:grpSpPr>
            <a:xfrm>
              <a:off x="6473520" y="949320"/>
              <a:ext cx="82440" cy="2893680"/>
              <a:chOff x="6473520" y="949320"/>
              <a:chExt cx="82440" cy="2893680"/>
            </a:xfrm>
          </p:grpSpPr>
          <p:sp>
            <p:nvSpPr>
              <p:cNvPr id="108" name=""/>
              <p:cNvSpPr/>
              <p:nvPr/>
            </p:nvSpPr>
            <p:spPr>
              <a:xfrm flipV="1">
                <a:off x="6486480" y="949320"/>
                <a:ext cx="0" cy="289368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"/>
              <p:cNvSpPr/>
              <p:nvPr/>
            </p:nvSpPr>
            <p:spPr>
              <a:xfrm flipH="1">
                <a:off x="6473520" y="3843000"/>
                <a:ext cx="824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"/>
              <p:cNvSpPr/>
              <p:nvPr/>
            </p:nvSpPr>
            <p:spPr>
              <a:xfrm flipH="1">
                <a:off x="6473520" y="3263760"/>
                <a:ext cx="824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H="1">
                <a:off x="6473520" y="2685960"/>
                <a:ext cx="824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"/>
              <p:cNvSpPr/>
              <p:nvPr/>
            </p:nvSpPr>
            <p:spPr>
              <a:xfrm flipH="1">
                <a:off x="6473520" y="2106360"/>
                <a:ext cx="824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"/>
              <p:cNvSpPr/>
              <p:nvPr/>
            </p:nvSpPr>
            <p:spPr>
              <a:xfrm flipH="1">
                <a:off x="6473520" y="1528560"/>
                <a:ext cx="824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H="1">
                <a:off x="6473520" y="949320"/>
                <a:ext cx="82440" cy="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5" name=""/>
            <p:cNvSpPr/>
            <p:nvPr/>
          </p:nvSpPr>
          <p:spPr>
            <a:xfrm>
              <a:off x="6620040" y="799920"/>
              <a:ext cx="3618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7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395440" y="245268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778120" y="205884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3154320" y="207792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535200" y="243504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916440" y="2044440"/>
              <a:ext cx="261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2400480" y="957240"/>
              <a:ext cx="237960" cy="14857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778120" y="934920"/>
              <a:ext cx="237960" cy="11142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3530520" y="934920"/>
              <a:ext cx="238320" cy="14954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3159000" y="944280"/>
              <a:ext cx="238320" cy="11145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3921120" y="944280"/>
              <a:ext cx="237960" cy="10861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551480" y="3450960"/>
              <a:ext cx="261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938840" y="3600360"/>
              <a:ext cx="261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310360" y="2952720"/>
              <a:ext cx="261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5691240" y="3390840"/>
              <a:ext cx="261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6072120" y="291456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568760" y="938160"/>
              <a:ext cx="238320" cy="249552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943520" y="925200"/>
              <a:ext cx="237960" cy="26733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5324400" y="925200"/>
              <a:ext cx="238320" cy="201960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5711760" y="931680"/>
              <a:ext cx="238320" cy="245124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6080040" y="931680"/>
              <a:ext cx="238320" cy="1974960"/>
            </a:xfrm>
            <a:prstGeom prst="rect">
              <a:avLst/>
            </a:prstGeom>
            <a:solidFill>
              <a:srgbClr val="00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H="1" rot="5400000">
              <a:off x="5548320" y="2246400"/>
              <a:ext cx="3220920" cy="28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900" spc="-1" strike="noStrike">
                  <a:solidFill>
                    <a:srgbClr val="000000"/>
                  </a:solidFill>
                  <a:latin typeface="Arial"/>
                </a:rPr>
                <a:t>% free (white)/bound (black)</a:t>
              </a:r>
              <a:endParaRPr b="0" lang="en-US" sz="1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7" name=""/>
          <p:cNvSpPr/>
          <p:nvPr/>
        </p:nvSpPr>
        <p:spPr>
          <a:xfrm>
            <a:off x="110520" y="8424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829080" y="3985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139" name=""/>
          <p:cNvGraphicFramePr/>
          <p:nvPr/>
        </p:nvGraphicFramePr>
        <p:xfrm>
          <a:off x="1589040" y="4869000"/>
          <a:ext cx="3487680" cy="1466640"/>
        </p:xfrm>
        <a:graphic>
          <a:graphicData uri="http://schemas.openxmlformats.org/drawingml/2006/table">
            <a:tbl>
              <a:tblPr/>
              <a:tblGrid>
                <a:gridCol w="1371600"/>
                <a:gridCol w="766800"/>
                <a:gridCol w="1349280"/>
              </a:tblGrid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notyp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max/K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Vmax/Km normalize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S5BΔ21-1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S5BΔ21-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S5BΔ21-3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S5BΔ21-4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59x10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.77x10</a:t>
                      </a:r>
                      <a:r>
                        <a:rPr b="0" lang="en-US" sz="10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624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S5BΔ21-5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140" name=""/>
          <p:cNvSpPr/>
          <p:nvPr/>
        </p:nvSpPr>
        <p:spPr>
          <a:xfrm>
            <a:off x="829080" y="45813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8T13:22:48Z</dcterms:created>
  <dc:creator>Antonio Mas</dc:creator>
  <dc:description/>
  <dc:language>en-US</dc:language>
  <cp:lastModifiedBy>Antonio Mas</cp:lastModifiedBy>
  <dcterms:modified xsi:type="dcterms:W3CDTF">2011-03-01T12:11:18Z</dcterms:modified>
  <cp:revision>3</cp:revision>
  <dc:subject/>
  <dc:title>Diapositiva 1</dc:title>
</cp:coreProperties>
</file>